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10"/>
  </p:normalViewPr>
  <p:slideViewPr>
    <p:cSldViewPr snapToGrid="0">
      <p:cViewPr varScale="1">
        <p:scale>
          <a:sx n="86" d="100"/>
          <a:sy n="86" d="100"/>
        </p:scale>
        <p:origin x="10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BRAUN" userId="4db598aa-08ef-409b-ab55-f6c69a0ee51f" providerId="ADAL" clId="{295E84EE-ECE1-8745-BD3E-C7E326352D77}"/>
    <pc:docChg chg="delSld">
      <pc:chgData name="DAVID BRAUN" userId="4db598aa-08ef-409b-ab55-f6c69a0ee51f" providerId="ADAL" clId="{295E84EE-ECE1-8745-BD3E-C7E326352D77}" dt="2024-07-05T05:23:38.348" v="0" actId="2696"/>
      <pc:docMkLst>
        <pc:docMk/>
      </pc:docMkLst>
      <pc:sldChg chg="del">
        <pc:chgData name="DAVID BRAUN" userId="4db598aa-08ef-409b-ab55-f6c69a0ee51f" providerId="ADAL" clId="{295E84EE-ECE1-8745-BD3E-C7E326352D77}" dt="2024-07-05T05:23:38.348" v="0" actId="2696"/>
        <pc:sldMkLst>
          <pc:docMk/>
          <pc:sldMk cId="3634858068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82BA3-3DD4-47A2-1385-0B2CD255EA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55A4A96-1462-3654-005C-54019051DA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0241E5-488B-A481-89BC-366E8B9B7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13E1DF-02DE-823B-484E-8893B9AA01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629A30-6972-9374-AA77-ACC54723CE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645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7A057-606F-6270-D82C-507DB90A77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283877-1802-CA86-DDB6-2005AC4DF6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6BD754-3B84-C1C4-89CA-D6AD11C24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D40F91-38B7-D267-E326-8B626E1657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D78F8-FC3D-D9A3-9918-CBB5F2E8A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160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C3B91C-1918-B243-A252-A0A1742B7E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969041-42A5-25AA-87F1-46B689ED12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BEC2FD-4557-B95C-9201-DDF3FE702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25B6A0-7F9E-48B1-8B81-15A3201A5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B563F2-5043-1B07-B5CF-206FD3E1DF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02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834204-6A40-7411-775C-F7069FD406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68D027-2056-6C8B-63AA-9F1AC205E9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11B217-29F6-B964-6E1C-52AB96B0D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C574CD-DE0E-103F-D414-6DD3A37D18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FCF98-9037-38DA-DCE7-53F1FE042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488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432C51-2D01-8FCF-FBC4-6DE94028C6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55176A-8C71-F848-A3FD-0F46844BE6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D6748E-4A09-41BA-7458-C7995F90B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A020E8-296C-7E29-BE46-D2FECC64B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9098C-3C17-05C7-0CEA-0A8385740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491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978658-9027-D55E-1DC3-68FE146795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EE55DF-FFFB-8BAF-1BA3-67C2275F5F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0BBB9B-95CA-8DCD-B4D6-BEDAE4C48A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7A1F93-2C8F-6052-6C48-91BF28FB1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734E24-58BF-CF7F-4978-406E1B3F1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69F4B9-8DFE-57A2-3E86-C36EEE7EE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349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5C1278-866F-5EBC-0407-A0B03C0392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750FC5-A6F6-F8D9-7FC5-4FA525D0E5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9E814D-7BA7-32E8-84E2-F482EB6DEB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92EE8D-F39A-9A61-2840-84EC259FF3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F5E2D0-E7C7-253D-3025-05E6CB75B8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D832D9-01DD-6227-51A7-6CBF5F1F1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D183BA-A276-3E02-B19D-5FB18CDC29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4B4D65B-B677-8988-2688-00873B542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138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4CD774-FA01-5CBE-2646-EAC1060AF1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FC2294-9355-0962-08E5-CE75CE269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5A7743-E0B0-7A62-CB7C-020156E0E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F3C408-7749-9610-54A6-D3DD7C58D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572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9F546B-F0D6-4F1B-3491-B9D604E03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32D206-5A6A-5099-D304-3AD851AE9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DDAF28-6211-129A-99D8-07BE7A543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170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98E34-43D6-DAEE-D72E-BFD4DA95E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BCBEB2-87FC-81AC-8192-52CA7244B2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FFB1B6-4191-E3CD-2A87-618AAE9A96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C6C0AF-3AC2-C916-CCED-3816E413B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0F023B-07D3-693D-8BC8-599B8E845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27F120-25A0-814C-22F7-031A04521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147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EB02C4-2717-2E84-AD1B-BEE195334F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E45DB4-F2E5-39FD-7579-5FD030AB4A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737CD1-EB40-DD7C-A3A7-ACE828911D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351E2F-A0F7-4817-5683-D0A05EF7A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402815-8F74-08A1-FB90-9301979B9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135192-DD53-4860-B3FC-E7D3A4DCD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055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F594F39-E112-65E4-894F-75062AB33A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57A077-E53F-4E9E-8030-9DAB9F68B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1F46ED-9B60-7B5A-6652-FE29610F70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5F5EA3-85E3-824C-A438-A1EC5608AD2B}" type="datetimeFigureOut">
              <a:rPr lang="en-US" smtClean="0"/>
              <a:t>7/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F99C9C-29BA-B576-F309-607155849F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90D37C-CC58-C275-BC4E-29182AAB779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95D533-28AE-A249-82E7-D1A89F65C9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128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130143-8302-32C2-ED01-48C6C9DBF9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00825" y="365125"/>
            <a:ext cx="6909623" cy="820207"/>
          </a:xfrm>
        </p:spPr>
        <p:txBody>
          <a:bodyPr>
            <a:normAutofit fontScale="90000"/>
          </a:bodyPr>
          <a:lstStyle/>
          <a:p>
            <a:pPr marL="0" marR="0">
              <a:lnSpc>
                <a:spcPct val="1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1. Change in weight, length and head circumference Z-scores between birth, NICU discharge and at 12-months follow-up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CC29CC23-65E3-B6CF-9F11-C80EC3E516B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400825" y="1320800"/>
            <a:ext cx="6909623" cy="5012267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268D976-DC27-FA69-D0D3-26C611298AA2}"/>
              </a:ext>
            </a:extLst>
          </p:cNvPr>
          <p:cNvSpPr txBox="1"/>
          <p:nvPr/>
        </p:nvSpPr>
        <p:spPr>
          <a:xfrm>
            <a:off x="2400825" y="6468535"/>
            <a:ext cx="76745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* P &lt; 0.05 compared to birth data; † p &lt; 0.05 compared to discharge value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2325188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3f8a7bc4-e337-47a5-a0fc-0d512c0e05f1}" enabled="0" method="" siteId="{3f8a7bc4-e337-47a5-a0fc-0d512c0e05f1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1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Supplemental Figure 1. Change in weight, length and head circumference Z-scores between birth, NICU discharge and at 12-months follow-up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 Braun</dc:creator>
  <cp:lastModifiedBy>David Braun</cp:lastModifiedBy>
  <cp:revision>1</cp:revision>
  <dcterms:created xsi:type="dcterms:W3CDTF">2024-07-05T04:54:00Z</dcterms:created>
  <dcterms:modified xsi:type="dcterms:W3CDTF">2024-07-05T05:23:48Z</dcterms:modified>
</cp:coreProperties>
</file>